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UPusheng" initials="PX" lastIdx="1" clrIdx="0">
    <p:extLst>
      <p:ext uri="{19B8F6BF-5375-455C-9EA6-DF929625EA0E}">
        <p15:presenceInfo xmlns:p15="http://schemas.microsoft.com/office/powerpoint/2012/main" userId="S::24520181154696@stu.xmu.edu.cn::671c2a3f-db04-4608-b7cf-9d4a0f385ab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DCF0"/>
    <a:srgbClr val="F2FBD1"/>
    <a:srgbClr val="F0DCE4"/>
    <a:srgbClr val="8779B8"/>
    <a:srgbClr val="4D6B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15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C258EA-A1ED-C6D5-56E7-E01B1B5503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0AED970-9624-DD58-116D-F4C44A1BCE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333426-B4D6-DB09-0999-FBEC1177C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BD98E4-22FF-9E06-12F9-30775AE876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6663D8-991D-224A-9393-97F48BD6F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69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9DF64C-D0C8-A66C-0FC9-514C1C42FD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96FDEE2-B2D4-A980-0F69-015CD1EA3C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21C00F-E858-5668-4DE7-101F9E8BA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CE55C0-778F-06E5-8B38-CEBCF5C55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96615F-1EC2-79A2-C044-4B509894F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061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6F830FC-8C15-FE91-6054-914ED1CB72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3D1999F-222C-17B2-06C0-21BFFC84B8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6832E5-78A0-6895-153D-347C41EC7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7A45C7-7732-9E68-74D3-68D027962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D1E6A6-E26B-98F5-833D-A457FAC41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142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FA875B-607E-28B0-1096-527B06B59B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2CA7E4F-82C0-3639-0913-8D6929A190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391251-2A3A-FAF4-1E3B-73C3F5ABC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F5B202-FB57-BABD-4826-B8DC94002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4EFFA3-7933-04C5-F058-57D3698E0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774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EFF8DC-6912-0F73-0898-F5BE1C9E2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FC9F35-718B-5D5D-1731-1D1988C4A2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82EFE4-8BD8-0528-35DD-4CF04B8D0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3B48A6-73E6-AC95-FADB-A6EE9B8BA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DFB319-29A1-9807-A59C-45891B595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954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10E775-C85B-73E0-CC0E-CA6202ECC4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C91EFA-86E1-8DC1-4B16-1F5286E9E5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97354D3-7F38-852D-64CB-B1D9DB2483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00CDF2-F85D-01F1-426A-376B24506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17DFCD0-99F8-0F98-A7A6-FC820FDA77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9584F1-4776-D8A3-739F-6289BF477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903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1EA106-272B-755C-18DD-0976AC0E8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EB6491-B206-6713-840C-A1A3CE3B0C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C29242-9403-24C5-0F69-A5D48EA5E0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D69B0D7-D222-02D5-1944-2C8882052E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AEACB50-94B8-F137-7D1C-8699EF069C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AC38E0C-EE81-0ED8-E7B0-8A71D0250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E9E0F56-8453-C1C7-E15C-663E765B0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33109DA-2B46-F2E6-A6B8-83B682F74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739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065B01-530B-163C-5D40-98B0876610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534C6C4-FDED-7D58-8FE0-D320D5E04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C8B7206-4991-0E60-EE59-8A6847645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FF76102-6312-9E44-688D-D52A4564F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662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D1BDE74-9F7C-E486-ED51-655423827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48320B0-5924-F7D9-453B-DACBE22DC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A519CC5-ED45-C619-7852-B0805398A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835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D69AB6-C94A-656B-B880-7516EE82A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07FBBA-26A9-9048-049B-8F7CB6D45C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ADA5550-555F-4031-5B51-9871F54D71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B5AC80-28DB-E29E-AD72-9C60B5C50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58E68-CF17-3090-BB27-7BB60981E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FB921D-2DBE-FF22-B40C-191A68517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82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189AF3-3275-FBBD-317C-0C988DD355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F47A250-A0B7-0D01-0AA2-E1D6B48F87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2D677F3-8698-1B57-73A6-92E8CA1A09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E4A012-68D0-A894-5699-B2F4FFFF9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5ED23E2-D623-C842-D7E6-34133376A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0580C3-EE9E-3663-09A9-B90630867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679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73A3893-CD7B-C38A-5C43-3D5EAA3604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8E0497-BC5A-6D54-CAC2-57DD77F621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4F7F38-3681-EE87-F9BD-A53917165A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0AFFAF-A3D6-44FD-A008-AB5937284F60}" type="datetimeFigureOut">
              <a:rPr lang="en-US" smtClean="0"/>
              <a:t>2/25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941A8E-4418-656B-D051-F69BED5296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D90CAF-9F24-93DE-CF20-AB6BC1C836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916B9B-DDB7-4C56-8910-DEEAA8061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727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4C9A0CE-2E17-6DCC-7CFA-E2E094387E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ECEABEC-BDAE-9F23-B4CD-6ADB156FAB57}"/>
              </a:ext>
            </a:extLst>
          </p:cNvPr>
          <p:cNvSpPr txBox="1"/>
          <p:nvPr/>
        </p:nvSpPr>
        <p:spPr>
          <a:xfrm>
            <a:off x="1086592" y="5654435"/>
            <a:ext cx="99726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ogical reasoning framework for diagnostic questions, as shared by all four LLMs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矩形: 圆角 81">
            <a:extLst>
              <a:ext uri="{FF2B5EF4-FFF2-40B4-BE49-F238E27FC236}">
                <a16:creationId xmlns:a16="http://schemas.microsoft.com/office/drawing/2014/main" id="{DF84D0CA-F617-3B6A-1BD9-7921C193C642}"/>
              </a:ext>
            </a:extLst>
          </p:cNvPr>
          <p:cNvSpPr/>
          <p:nvPr/>
        </p:nvSpPr>
        <p:spPr>
          <a:xfrm>
            <a:off x="2483842" y="1135909"/>
            <a:ext cx="6226680" cy="431635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marize medical history to identify key clues</a:t>
            </a:r>
          </a:p>
        </p:txBody>
      </p:sp>
      <p:sp>
        <p:nvSpPr>
          <p:cNvPr id="7" name="矩形: 圆角 6">
            <a:extLst>
              <a:ext uri="{FF2B5EF4-FFF2-40B4-BE49-F238E27FC236}">
                <a16:creationId xmlns:a16="http://schemas.microsoft.com/office/drawing/2014/main" id="{9122962F-F5E1-E948-7D38-8F3B5A1E6916}"/>
              </a:ext>
            </a:extLst>
          </p:cNvPr>
          <p:cNvSpPr/>
          <p:nvPr/>
        </p:nvSpPr>
        <p:spPr>
          <a:xfrm>
            <a:off x="2483842" y="4931600"/>
            <a:ext cx="6226680" cy="431635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nal answer</a:t>
            </a:r>
          </a:p>
        </p:txBody>
      </p:sp>
      <p:sp>
        <p:nvSpPr>
          <p:cNvPr id="8" name="矩形: 圆角 7">
            <a:extLst>
              <a:ext uri="{FF2B5EF4-FFF2-40B4-BE49-F238E27FC236}">
                <a16:creationId xmlns:a16="http://schemas.microsoft.com/office/drawing/2014/main" id="{8F9022F2-593E-6F9D-313D-ABE4F3E75027}"/>
              </a:ext>
            </a:extLst>
          </p:cNvPr>
          <p:cNvSpPr/>
          <p:nvPr/>
        </p:nvSpPr>
        <p:spPr>
          <a:xfrm>
            <a:off x="2483842" y="3812248"/>
            <a:ext cx="6226680" cy="658875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duct differential diagnosis for each option, and analyze supporting and non-supporting factors</a:t>
            </a:r>
          </a:p>
        </p:txBody>
      </p:sp>
      <p:sp>
        <p:nvSpPr>
          <p:cNvPr id="9" name="矩形: 圆角 8">
            <a:extLst>
              <a:ext uri="{FF2B5EF4-FFF2-40B4-BE49-F238E27FC236}">
                <a16:creationId xmlns:a16="http://schemas.microsoft.com/office/drawing/2014/main" id="{509BAE6D-25F2-2712-45F0-C154EAE024D3}"/>
              </a:ext>
            </a:extLst>
          </p:cNvPr>
          <p:cNvSpPr/>
          <p:nvPr/>
        </p:nvSpPr>
        <p:spPr>
          <a:xfrm>
            <a:off x="2483842" y="2920135"/>
            <a:ext cx="6226680" cy="431635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vide preliminary diagnosis with rationale</a:t>
            </a:r>
          </a:p>
        </p:txBody>
      </p:sp>
      <p:sp>
        <p:nvSpPr>
          <p:cNvPr id="10" name="矩形: 圆角 9">
            <a:extLst>
              <a:ext uri="{FF2B5EF4-FFF2-40B4-BE49-F238E27FC236}">
                <a16:creationId xmlns:a16="http://schemas.microsoft.com/office/drawing/2014/main" id="{4A90DD5F-27D3-B160-81C9-AA9371B9D73F}"/>
              </a:ext>
            </a:extLst>
          </p:cNvPr>
          <p:cNvSpPr/>
          <p:nvPr/>
        </p:nvSpPr>
        <p:spPr>
          <a:xfrm>
            <a:off x="2483842" y="2028022"/>
            <a:ext cx="6226680" cy="431635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light critical positive clinical signs</a:t>
            </a:r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3B613A43-6BE3-6619-84A6-82A8A2EB020B}"/>
              </a:ext>
            </a:extLst>
          </p:cNvPr>
          <p:cNvCxnSpPr>
            <a:stCxn id="82" idx="2"/>
            <a:endCxn id="10" idx="0"/>
          </p:cNvCxnSpPr>
          <p:nvPr/>
        </p:nvCxnSpPr>
        <p:spPr>
          <a:xfrm>
            <a:off x="5597182" y="1567544"/>
            <a:ext cx="0" cy="460478"/>
          </a:xfrm>
          <a:prstGeom prst="straightConnector1">
            <a:avLst/>
          </a:prstGeom>
          <a:ln w="285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EC08EC30-CC25-2340-A93B-D0F6A25556C9}"/>
              </a:ext>
            </a:extLst>
          </p:cNvPr>
          <p:cNvCxnSpPr>
            <a:stCxn id="10" idx="2"/>
            <a:endCxn id="9" idx="0"/>
          </p:cNvCxnSpPr>
          <p:nvPr/>
        </p:nvCxnSpPr>
        <p:spPr>
          <a:xfrm>
            <a:off x="5597182" y="2459657"/>
            <a:ext cx="0" cy="460478"/>
          </a:xfrm>
          <a:prstGeom prst="straightConnector1">
            <a:avLst/>
          </a:prstGeom>
          <a:ln w="285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09F3743C-5A17-4898-4725-E10D2D8AFC6F}"/>
              </a:ext>
            </a:extLst>
          </p:cNvPr>
          <p:cNvCxnSpPr>
            <a:stCxn id="9" idx="2"/>
            <a:endCxn id="8" idx="0"/>
          </p:cNvCxnSpPr>
          <p:nvPr/>
        </p:nvCxnSpPr>
        <p:spPr>
          <a:xfrm>
            <a:off x="5597182" y="3351770"/>
            <a:ext cx="0" cy="460478"/>
          </a:xfrm>
          <a:prstGeom prst="straightConnector1">
            <a:avLst/>
          </a:prstGeom>
          <a:ln w="285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203379AA-E8A7-DCC1-4E76-64447010F71C}"/>
              </a:ext>
            </a:extLst>
          </p:cNvPr>
          <p:cNvCxnSpPr>
            <a:stCxn id="8" idx="2"/>
            <a:endCxn id="7" idx="0"/>
          </p:cNvCxnSpPr>
          <p:nvPr/>
        </p:nvCxnSpPr>
        <p:spPr>
          <a:xfrm>
            <a:off x="5597182" y="4471123"/>
            <a:ext cx="0" cy="460477"/>
          </a:xfrm>
          <a:prstGeom prst="straightConnector1">
            <a:avLst/>
          </a:prstGeom>
          <a:ln w="285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51263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9</TotalTime>
  <Words>50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UPusheng</dc:creator>
  <cp:lastModifiedBy>XUPusheng</cp:lastModifiedBy>
  <cp:revision>15</cp:revision>
  <dcterms:created xsi:type="dcterms:W3CDTF">2025-02-21T08:06:50Z</dcterms:created>
  <dcterms:modified xsi:type="dcterms:W3CDTF">2025-02-25T07:35:47Z</dcterms:modified>
</cp:coreProperties>
</file>